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8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7FF84"/>
    <a:srgbClr val="FBBEFF"/>
    <a:srgbClr val="FF8CCA"/>
    <a:srgbClr val="5D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84E427A-3D55-4303-BF80-6455036E1DE7}" styleName="Designformatvorlage 1 - Akz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40" autoAdjust="0"/>
    <p:restoredTop sz="96310" autoAdjust="0"/>
  </p:normalViewPr>
  <p:slideViewPr>
    <p:cSldViewPr>
      <p:cViewPr>
        <p:scale>
          <a:sx n="130" d="100"/>
          <a:sy n="130" d="100"/>
        </p:scale>
        <p:origin x="-2154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862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67C758-A4EB-4A41-8BAB-A84C94E459BF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383" y="4776856"/>
            <a:ext cx="5436909" cy="390895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862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F47CAC-7AD0-4285-B834-8E3EF59129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9455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40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336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981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38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315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920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002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010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887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349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8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367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saturation sat="15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17396" y="3076963"/>
            <a:ext cx="3657600" cy="3657600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2633663" y="294280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52" name="Picture 5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5205" y="652464"/>
            <a:ext cx="2286000" cy="2286000"/>
          </a:xfrm>
          <a:prstGeom prst="rect">
            <a:avLst/>
          </a:prstGeom>
        </p:spPr>
      </p:pic>
      <p:sp>
        <p:nvSpPr>
          <p:cNvPr id="53" name="TextBox 52"/>
          <p:cNvSpPr txBox="1"/>
          <p:nvPr/>
        </p:nvSpPr>
        <p:spPr>
          <a:xfrm>
            <a:off x="141576" y="51396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4" name="Picture 5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3201" y="3076963"/>
            <a:ext cx="2286000" cy="2286000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14834" y="652464"/>
            <a:ext cx="2286000" cy="2286000"/>
          </a:xfrm>
          <a:prstGeom prst="rect">
            <a:avLst/>
          </a:prstGeom>
        </p:spPr>
      </p:pic>
      <p:sp>
        <p:nvSpPr>
          <p:cNvPr id="56" name="TextBox 55"/>
          <p:cNvSpPr txBox="1"/>
          <p:nvPr/>
        </p:nvSpPr>
        <p:spPr>
          <a:xfrm>
            <a:off x="2571205" y="51396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135564" y="293846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" name="Oval 1">
            <a:extLst>
              <a:ext uri="{FF2B5EF4-FFF2-40B4-BE49-F238E27FC236}">
                <a16:creationId xmlns="" xmlns:a16="http://schemas.microsoft.com/office/drawing/2014/main" id="{40942F28-BD0E-8547-855F-8A3EAD2D8EED}"/>
              </a:ext>
            </a:extLst>
          </p:cNvPr>
          <p:cNvSpPr/>
          <p:nvPr/>
        </p:nvSpPr>
        <p:spPr>
          <a:xfrm rot="1976020">
            <a:off x="3105520" y="4654769"/>
            <a:ext cx="940118" cy="524033"/>
          </a:xfrm>
          <a:prstGeom prst="ellipse">
            <a:avLst/>
          </a:prstGeom>
          <a:noFill/>
          <a:ln w="6350">
            <a:solidFill>
              <a:srgbClr val="5DFFFF"/>
            </a:solidFill>
            <a:prstDash val="dash"/>
            <a:extLst>
              <a:ext uri="{C807C97D-BFC1-408E-A445-0C87EB9F89A2}">
                <ask:lineSketchStyleProps xmlns="" xmlns:ask="http://schemas.microsoft.com/office/drawing/2018/sketchyshapes" sd="1219033472">
                  <a:custGeom>
                    <a:avLst/>
                    <a:gdLst>
                      <a:gd name="connsiteX0" fmla="*/ 0 w 940118"/>
                      <a:gd name="connsiteY0" fmla="*/ 262017 h 524033"/>
                      <a:gd name="connsiteX1" fmla="*/ 470059 w 940118"/>
                      <a:gd name="connsiteY1" fmla="*/ 0 h 524033"/>
                      <a:gd name="connsiteX2" fmla="*/ 940118 w 940118"/>
                      <a:gd name="connsiteY2" fmla="*/ 262017 h 524033"/>
                      <a:gd name="connsiteX3" fmla="*/ 470059 w 940118"/>
                      <a:gd name="connsiteY3" fmla="*/ 524034 h 524033"/>
                      <a:gd name="connsiteX4" fmla="*/ 0 w 940118"/>
                      <a:gd name="connsiteY4" fmla="*/ 262017 h 524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940118" h="524033" extrusionOk="0">
                        <a:moveTo>
                          <a:pt x="0" y="262017"/>
                        </a:moveTo>
                        <a:cubicBezTo>
                          <a:pt x="-60166" y="80197"/>
                          <a:pt x="178572" y="11966"/>
                          <a:pt x="470059" y="0"/>
                        </a:cubicBezTo>
                        <a:cubicBezTo>
                          <a:pt x="751396" y="4575"/>
                          <a:pt x="920519" y="117932"/>
                          <a:pt x="940118" y="262017"/>
                        </a:cubicBezTo>
                        <a:cubicBezTo>
                          <a:pt x="902627" y="443337"/>
                          <a:pt x="717865" y="589257"/>
                          <a:pt x="470059" y="524034"/>
                        </a:cubicBezTo>
                        <a:cubicBezTo>
                          <a:pt x="201201" y="518972"/>
                          <a:pt x="24924" y="418634"/>
                          <a:pt x="0" y="262017"/>
                        </a:cubicBezTo>
                        <a:close/>
                      </a:path>
                    </a:pathLst>
                  </a:custGeom>
                  <ask:type>
                    <ask:lineSketchNone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4" name="Oval 13">
            <a:extLst>
              <a:ext uri="{FF2B5EF4-FFF2-40B4-BE49-F238E27FC236}">
                <a16:creationId xmlns="" xmlns:a16="http://schemas.microsoft.com/office/drawing/2014/main" id="{D63CC48A-0AF5-8046-B9A0-C9509566B01E}"/>
              </a:ext>
            </a:extLst>
          </p:cNvPr>
          <p:cNvSpPr/>
          <p:nvPr/>
        </p:nvSpPr>
        <p:spPr>
          <a:xfrm rot="3916827">
            <a:off x="2459622" y="5245523"/>
            <a:ext cx="2241226" cy="524033"/>
          </a:xfrm>
          <a:prstGeom prst="ellipse">
            <a:avLst/>
          </a:prstGeom>
          <a:noFill/>
          <a:ln w="6350">
            <a:solidFill>
              <a:srgbClr val="B7FF84"/>
            </a:solidFill>
            <a:prstDash val="dash"/>
            <a:extLst>
              <a:ext uri="{C807C97D-BFC1-408E-A445-0C87EB9F89A2}">
                <ask:lineSketchStyleProps xmlns="" xmlns:ask="http://schemas.microsoft.com/office/drawing/2018/sketchyshapes" sd="1219033472">
                  <a:custGeom>
                    <a:avLst/>
                    <a:gdLst>
                      <a:gd name="connsiteX0" fmla="*/ 0 w 940118"/>
                      <a:gd name="connsiteY0" fmla="*/ 262017 h 524033"/>
                      <a:gd name="connsiteX1" fmla="*/ 470059 w 940118"/>
                      <a:gd name="connsiteY1" fmla="*/ 0 h 524033"/>
                      <a:gd name="connsiteX2" fmla="*/ 940118 w 940118"/>
                      <a:gd name="connsiteY2" fmla="*/ 262017 h 524033"/>
                      <a:gd name="connsiteX3" fmla="*/ 470059 w 940118"/>
                      <a:gd name="connsiteY3" fmla="*/ 524034 h 524033"/>
                      <a:gd name="connsiteX4" fmla="*/ 0 w 940118"/>
                      <a:gd name="connsiteY4" fmla="*/ 262017 h 524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940118" h="524033" extrusionOk="0">
                        <a:moveTo>
                          <a:pt x="0" y="262017"/>
                        </a:moveTo>
                        <a:cubicBezTo>
                          <a:pt x="-60166" y="80197"/>
                          <a:pt x="178572" y="11966"/>
                          <a:pt x="470059" y="0"/>
                        </a:cubicBezTo>
                        <a:cubicBezTo>
                          <a:pt x="751396" y="4575"/>
                          <a:pt x="920519" y="117932"/>
                          <a:pt x="940118" y="262017"/>
                        </a:cubicBezTo>
                        <a:cubicBezTo>
                          <a:pt x="902627" y="443337"/>
                          <a:pt x="717865" y="589257"/>
                          <a:pt x="470059" y="524034"/>
                        </a:cubicBezTo>
                        <a:cubicBezTo>
                          <a:pt x="201201" y="518972"/>
                          <a:pt x="24924" y="418634"/>
                          <a:pt x="0" y="262017"/>
                        </a:cubicBezTo>
                        <a:close/>
                      </a:path>
                    </a:pathLst>
                  </a:custGeom>
                  <ask:type>
                    <ask:lineSketchNone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5" name="Oval 14">
            <a:extLst>
              <a:ext uri="{FF2B5EF4-FFF2-40B4-BE49-F238E27FC236}">
                <a16:creationId xmlns="" xmlns:a16="http://schemas.microsoft.com/office/drawing/2014/main" id="{E5A09011-179B-EF4D-8312-35FC87825B39}"/>
              </a:ext>
            </a:extLst>
          </p:cNvPr>
          <p:cNvSpPr/>
          <p:nvPr/>
        </p:nvSpPr>
        <p:spPr>
          <a:xfrm rot="15911113">
            <a:off x="4612966" y="4917636"/>
            <a:ext cx="1387839" cy="656977"/>
          </a:xfrm>
          <a:prstGeom prst="ellipse">
            <a:avLst/>
          </a:prstGeom>
          <a:noFill/>
          <a:ln w="6350">
            <a:solidFill>
              <a:srgbClr val="FF8CCA"/>
            </a:solidFill>
            <a:prstDash val="dash"/>
            <a:extLst>
              <a:ext uri="{C807C97D-BFC1-408E-A445-0C87EB9F89A2}">
                <ask:lineSketchStyleProps xmlns="" xmlns:ask="http://schemas.microsoft.com/office/drawing/2018/sketchyshapes" sd="1219033472">
                  <a:custGeom>
                    <a:avLst/>
                    <a:gdLst>
                      <a:gd name="connsiteX0" fmla="*/ 0 w 940118"/>
                      <a:gd name="connsiteY0" fmla="*/ 262017 h 524033"/>
                      <a:gd name="connsiteX1" fmla="*/ 470059 w 940118"/>
                      <a:gd name="connsiteY1" fmla="*/ 0 h 524033"/>
                      <a:gd name="connsiteX2" fmla="*/ 940118 w 940118"/>
                      <a:gd name="connsiteY2" fmla="*/ 262017 h 524033"/>
                      <a:gd name="connsiteX3" fmla="*/ 470059 w 940118"/>
                      <a:gd name="connsiteY3" fmla="*/ 524034 h 524033"/>
                      <a:gd name="connsiteX4" fmla="*/ 0 w 940118"/>
                      <a:gd name="connsiteY4" fmla="*/ 262017 h 524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940118" h="524033" extrusionOk="0">
                        <a:moveTo>
                          <a:pt x="0" y="262017"/>
                        </a:moveTo>
                        <a:cubicBezTo>
                          <a:pt x="-60166" y="80197"/>
                          <a:pt x="178572" y="11966"/>
                          <a:pt x="470059" y="0"/>
                        </a:cubicBezTo>
                        <a:cubicBezTo>
                          <a:pt x="751396" y="4575"/>
                          <a:pt x="920519" y="117932"/>
                          <a:pt x="940118" y="262017"/>
                        </a:cubicBezTo>
                        <a:cubicBezTo>
                          <a:pt x="902627" y="443337"/>
                          <a:pt x="717865" y="589257"/>
                          <a:pt x="470059" y="524034"/>
                        </a:cubicBezTo>
                        <a:cubicBezTo>
                          <a:pt x="201201" y="518972"/>
                          <a:pt x="24924" y="418634"/>
                          <a:pt x="0" y="262017"/>
                        </a:cubicBezTo>
                        <a:close/>
                      </a:path>
                    </a:pathLst>
                  </a:custGeom>
                  <ask:type>
                    <ask:lineSketchNone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6" name="Oval 15">
            <a:extLst>
              <a:ext uri="{FF2B5EF4-FFF2-40B4-BE49-F238E27FC236}">
                <a16:creationId xmlns="" xmlns:a16="http://schemas.microsoft.com/office/drawing/2014/main" id="{96E176B0-9618-964A-9DDB-249BA1F023CB}"/>
              </a:ext>
            </a:extLst>
          </p:cNvPr>
          <p:cNvSpPr/>
          <p:nvPr/>
        </p:nvSpPr>
        <p:spPr>
          <a:xfrm rot="15206301">
            <a:off x="3848763" y="3790375"/>
            <a:ext cx="1864014" cy="656977"/>
          </a:xfrm>
          <a:prstGeom prst="ellipse">
            <a:avLst/>
          </a:prstGeom>
          <a:noFill/>
          <a:ln w="6350">
            <a:solidFill>
              <a:srgbClr val="FBBEFF"/>
            </a:solidFill>
            <a:prstDash val="dash"/>
            <a:extLst>
              <a:ext uri="{C807C97D-BFC1-408E-A445-0C87EB9F89A2}">
                <ask:lineSketchStyleProps xmlns="" xmlns:ask="http://schemas.microsoft.com/office/drawing/2018/sketchyshapes" sd="1219033472">
                  <a:custGeom>
                    <a:avLst/>
                    <a:gdLst>
                      <a:gd name="connsiteX0" fmla="*/ 0 w 940118"/>
                      <a:gd name="connsiteY0" fmla="*/ 262017 h 524033"/>
                      <a:gd name="connsiteX1" fmla="*/ 470059 w 940118"/>
                      <a:gd name="connsiteY1" fmla="*/ 0 h 524033"/>
                      <a:gd name="connsiteX2" fmla="*/ 940118 w 940118"/>
                      <a:gd name="connsiteY2" fmla="*/ 262017 h 524033"/>
                      <a:gd name="connsiteX3" fmla="*/ 470059 w 940118"/>
                      <a:gd name="connsiteY3" fmla="*/ 524034 h 524033"/>
                      <a:gd name="connsiteX4" fmla="*/ 0 w 940118"/>
                      <a:gd name="connsiteY4" fmla="*/ 262017 h 524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940118" h="524033" extrusionOk="0">
                        <a:moveTo>
                          <a:pt x="0" y="262017"/>
                        </a:moveTo>
                        <a:cubicBezTo>
                          <a:pt x="-60166" y="80197"/>
                          <a:pt x="178572" y="11966"/>
                          <a:pt x="470059" y="0"/>
                        </a:cubicBezTo>
                        <a:cubicBezTo>
                          <a:pt x="751396" y="4575"/>
                          <a:pt x="920519" y="117932"/>
                          <a:pt x="940118" y="262017"/>
                        </a:cubicBezTo>
                        <a:cubicBezTo>
                          <a:pt x="902627" y="443337"/>
                          <a:pt x="717865" y="589257"/>
                          <a:pt x="470059" y="524034"/>
                        </a:cubicBezTo>
                        <a:cubicBezTo>
                          <a:pt x="201201" y="518972"/>
                          <a:pt x="24924" y="418634"/>
                          <a:pt x="0" y="262017"/>
                        </a:cubicBezTo>
                        <a:close/>
                      </a:path>
                    </a:pathLst>
                  </a:custGeom>
                  <ask:type>
                    <ask:lineSketchNone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" name="Rechteck 2">
            <a:extLst>
              <a:ext uri="{FF2B5EF4-FFF2-40B4-BE49-F238E27FC236}">
                <a16:creationId xmlns="" xmlns:a16="http://schemas.microsoft.com/office/drawing/2014/main" id="{ACA897B2-0B62-6943-89F1-556E9CD9A0D5}"/>
              </a:ext>
            </a:extLst>
          </p:cNvPr>
          <p:cNvSpPr/>
          <p:nvPr/>
        </p:nvSpPr>
        <p:spPr>
          <a:xfrm>
            <a:off x="285205" y="7010400"/>
            <a:ext cx="6191795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8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Proteome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in A673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A673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45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UY922 ± 2 µM VE821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24 h and a quantitative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hol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om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as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pectrometr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3 individual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Volcan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lo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highl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lter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i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utof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&lt;0.05; log2-fol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&gt;0.5) after AUY922 (A), VE821 (B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i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mbina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AUY922+VE821) (C). (D) A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incipa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mponen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PCA)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om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R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tudi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plicate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ogethe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i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media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igges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ymbo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): DMSO (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) i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, AUY922 in pink, VE821 i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gree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UY922+VE821 i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agenta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ircle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roun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ser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han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fter PCA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ette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visua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epara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sp>
        <p:nvSpPr>
          <p:cNvPr id="17" name="TextBox 1"/>
          <p:cNvSpPr txBox="1"/>
          <p:nvPr/>
        </p:nvSpPr>
        <p:spPr>
          <a:xfrm>
            <a:off x="-13746" y="0"/>
            <a:ext cx="21339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orting Figure 8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83433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4</Words>
  <Application>Microsoft Office PowerPoint</Application>
  <PresentationFormat>A4-Papier (210x297 mm)</PresentationFormat>
  <Paragraphs>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>FL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n Marx</dc:creator>
  <cp:lastModifiedBy>Sonnemann, Jürgen</cp:lastModifiedBy>
  <cp:revision>1138</cp:revision>
  <cp:lastPrinted>2020-12-23T12:22:31Z</cp:lastPrinted>
  <dcterms:created xsi:type="dcterms:W3CDTF">2018-06-28T13:36:42Z</dcterms:created>
  <dcterms:modified xsi:type="dcterms:W3CDTF">2021-02-25T08:16:34Z</dcterms:modified>
</cp:coreProperties>
</file>